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8" d="100"/>
          <a:sy n="98" d="100"/>
        </p:scale>
        <p:origin x="-272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0BC3F6-322A-754C-A0EC-048BA0BE5845}" type="datetimeFigureOut">
              <a:rPr lang="en-US" smtClean="0"/>
              <a:t>8/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EB608B-958E-7746-B85B-223DD5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1632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 ID8 proliferate well when co-culture with  ASCs (500 cells)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71FFDD-6E70-3F48-BB23-2946D0D9A9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182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125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606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96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219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386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61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310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34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764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972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438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4D617-BFCE-314D-A94C-26979A47F0BB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6D96-B1D1-FE43-8036-9BEB42161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653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>
          <a:xfrm>
            <a:off x="3884613" y="8685213"/>
            <a:ext cx="2971800" cy="457200"/>
          </a:xfrm>
        </p:spPr>
        <p:txBody>
          <a:bodyPr/>
          <a:lstStyle/>
          <a:p>
            <a:fld id="{2A545166-490B-FF4E-AF3C-A17AE7072E8F}" type="slidenum">
              <a:rPr lang="en-US" smtClean="0"/>
              <a:t>1</a:t>
            </a:fld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-22057" y="120075"/>
            <a:ext cx="7515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3 Fig. </a:t>
            </a:r>
            <a:r>
              <a:rPr lang="en-US" dirty="0"/>
              <a:t>Ovarian cancer cell ID8 and IG10 </a:t>
            </a:r>
            <a:r>
              <a:rPr lang="en-US" dirty="0" smtClean="0"/>
              <a:t>proliferation in </a:t>
            </a:r>
          </a:p>
          <a:p>
            <a:r>
              <a:rPr lang="en-US" dirty="0"/>
              <a:t> </a:t>
            </a:r>
            <a:r>
              <a:rPr lang="en-US" dirty="0" smtClean="0"/>
              <a:t>co</a:t>
            </a:r>
            <a:r>
              <a:rPr lang="en-US" dirty="0"/>
              <a:t>-culture with ASC and migration in response to ASC conditioned </a:t>
            </a:r>
            <a:r>
              <a:rPr lang="en-US" dirty="0" smtClean="0"/>
              <a:t>media</a:t>
            </a:r>
            <a:endParaRPr lang="en-US" b="1" dirty="0" smtClean="0"/>
          </a:p>
        </p:txBody>
      </p:sp>
      <p:grpSp>
        <p:nvGrpSpPr>
          <p:cNvPr id="13" name="Group 12"/>
          <p:cNvGrpSpPr/>
          <p:nvPr/>
        </p:nvGrpSpPr>
        <p:grpSpPr>
          <a:xfrm>
            <a:off x="183244" y="1067739"/>
            <a:ext cx="3152545" cy="2152586"/>
            <a:chOff x="110234" y="1452337"/>
            <a:chExt cx="2987172" cy="1862364"/>
          </a:xfrm>
        </p:grpSpPr>
        <p:sp>
          <p:nvSpPr>
            <p:cNvPr id="12" name="Rectangle 11"/>
            <p:cNvSpPr/>
            <p:nvPr/>
          </p:nvSpPr>
          <p:spPr>
            <a:xfrm>
              <a:off x="110234" y="1452337"/>
              <a:ext cx="192281" cy="16192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6375" y="1515837"/>
              <a:ext cx="2891031" cy="1798864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4"/>
            <a:srcRect r="92645"/>
            <a:stretch/>
          </p:blipFill>
          <p:spPr>
            <a:xfrm>
              <a:off x="110234" y="1515837"/>
              <a:ext cx="231581" cy="1666876"/>
            </a:xfrm>
            <a:prstGeom prst="rect">
              <a:avLst/>
            </a:prstGeom>
          </p:spPr>
        </p:pic>
      </p:grpSp>
      <p:sp>
        <p:nvSpPr>
          <p:cNvPr id="11" name="TextBox 10"/>
          <p:cNvSpPr txBox="1"/>
          <p:nvPr/>
        </p:nvSpPr>
        <p:spPr>
          <a:xfrm>
            <a:off x="1524000" y="3508375"/>
            <a:ext cx="285750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22154" y="698407"/>
            <a:ext cx="37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28441" y="1089363"/>
            <a:ext cx="3524250" cy="1993719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3174698" y="714619"/>
            <a:ext cx="368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7557" y="3599088"/>
            <a:ext cx="2937134" cy="1831975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97029" y="3418443"/>
            <a:ext cx="366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</a:t>
            </a:r>
            <a:endParaRPr lang="en-US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7"/>
          <a:srcRect t="11738"/>
          <a:stretch/>
        </p:blipFill>
        <p:spPr>
          <a:xfrm>
            <a:off x="3884613" y="3385264"/>
            <a:ext cx="2768910" cy="201309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350719" y="3418443"/>
            <a:ext cx="384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.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282511" y="3418443"/>
            <a:ext cx="1602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ID8 migration to </a:t>
            </a:r>
            <a:r>
              <a:rPr lang="en-US" sz="1000" b="1" dirty="0" err="1" smtClean="0"/>
              <a:t>mASC</a:t>
            </a:r>
            <a:r>
              <a:rPr lang="en-US" sz="1000" b="1" dirty="0" smtClean="0"/>
              <a:t> CM</a:t>
            </a:r>
            <a:endParaRPr lang="en-US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504797" y="3385264"/>
            <a:ext cx="16687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IG10 migration to </a:t>
            </a:r>
            <a:r>
              <a:rPr lang="en-US" sz="1000" b="1" dirty="0" err="1" smtClean="0"/>
              <a:t>mASC</a:t>
            </a:r>
            <a:r>
              <a:rPr lang="en-US" sz="1000" b="1" dirty="0" smtClean="0"/>
              <a:t> CM</a:t>
            </a:r>
            <a:endParaRPr lang="en-US" sz="1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524000" y="894914"/>
            <a:ext cx="360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ID8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4998720" y="894914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IG10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5276725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1</Words>
  <Application>Microsoft Macintosh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DA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 Zhang</dc:creator>
  <cp:lastModifiedBy>Yan Zhang</cp:lastModifiedBy>
  <cp:revision>7</cp:revision>
  <dcterms:created xsi:type="dcterms:W3CDTF">2015-07-25T04:25:32Z</dcterms:created>
  <dcterms:modified xsi:type="dcterms:W3CDTF">2015-08-09T07:15:32Z</dcterms:modified>
</cp:coreProperties>
</file>